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651" autoAdjust="0"/>
    <p:restoredTop sz="89463" autoAdjust="0"/>
  </p:normalViewPr>
  <p:slideViewPr>
    <p:cSldViewPr snapToGrid="0">
      <p:cViewPr varScale="1">
        <p:scale>
          <a:sx n="101" d="100"/>
          <a:sy n="101" d="100"/>
        </p:scale>
        <p:origin x="3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294EE7-32C3-4A76-8BAA-0F2EFB63D6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395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3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16AC0F-394D-5904-2BCF-05AD201FC703}"/>
              </a:ext>
            </a:extLst>
          </p:cNvPr>
          <p:cNvSpPr txBox="1"/>
          <p:nvPr/>
        </p:nvSpPr>
        <p:spPr>
          <a:xfrm>
            <a:off x="7407945" y="598669"/>
            <a:ext cx="4326855" cy="5262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2: Immune cell composition changes in PBMCs following hypomethylating therapy in SCLC.</a:t>
            </a:r>
            <a:b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stimated proportions of major immune cell subsets in peripheral blood mononuclear cells (PBMCs) from patients with extensive-stage small-cell lung cancer at baseline (cycle 1 day 1; C1D1) and after treatment (cycle 2 day 5; C2D5), compared with healthy donor PBMCs. Cell populations shown include B cells, NK cells, CD4⁺ T cells, CD8⁺ T cells, monocytes, neutrophils, and eosinophils. Cell-type deconvolution was performed using DNA methylation-based reference signatures. Compared with healthy PBMCs, baseline samples exhibited elevated monocyte proportions, while post-treatment samples demonstrated reduced monocytes and B cells and increased eosinophils. Boxes show interquartile ranges with medians; whiskers represent 1.5× IQR; points denote outlie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908333-DA52-0DD8-341C-DD08A3346C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4412" y="0"/>
            <a:ext cx="54864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47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9</TotalTime>
  <Words>146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MDPI</cp:lastModifiedBy>
  <cp:revision>102</cp:revision>
  <cp:lastPrinted>2025-11-20T14:34:39Z</cp:lastPrinted>
  <dcterms:created xsi:type="dcterms:W3CDTF">2025-04-15T14:41:30Z</dcterms:created>
  <dcterms:modified xsi:type="dcterms:W3CDTF">2026-03-26T07:42:40Z</dcterms:modified>
</cp:coreProperties>
</file>